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7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123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92431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312653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46997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61691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26629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81315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2837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60864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5904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62466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47673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B16A7-51F3-4EC2-94A8-96981D0695DD}" type="datetimeFigureOut">
              <a:rPr lang="en-AU" smtClean="0"/>
              <a:t>16/10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340C2-3E22-467B-9B53-FC3E6F700F0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0883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0" y="0"/>
            <a:ext cx="91440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AU" altLang="en-US" sz="1400" b="1" u="sng" dirty="0" bmk="_Toc517011485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kumimoji="0" lang="en-AU" altLang="en-US" sz="1400" b="1" i="0" u="sng" strike="noStrike" cap="none" normalizeH="0" baseline="0" dirty="0" smtClean="0" bmk="_Toc517011485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igure 3:  Forest plot of studies assessing 24-hour urine volumes of 12-19 year olds</a:t>
            </a:r>
            <a:r>
              <a:rPr kumimoji="0" lang="en-AU" altLang="en-US" sz="1400" b="1" i="0" u="sng" strike="noStrike" cap="none" normalizeH="0" dirty="0" smtClean="0" bmk="_Toc517011485">
                <a:ln>
                  <a:noFill/>
                </a:ln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n=2230)</a:t>
            </a:r>
            <a:endParaRPr kumimoji="0" lang="en-AU" altLang="en-US" sz="1400" b="0" i="0" u="none" strike="noStrike" cap="none" normalizeH="0" baseline="0" dirty="0" smtClean="0">
              <a:ln>
                <a:noFill/>
              </a:ln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462661" y="393412"/>
            <a:ext cx="8228305" cy="276999"/>
            <a:chOff x="510787" y="393412"/>
            <a:chExt cx="8228305" cy="276999"/>
          </a:xfrm>
        </p:grpSpPr>
        <p:sp>
          <p:nvSpPr>
            <p:cNvPr id="7" name="TextBox 6"/>
            <p:cNvSpPr txBox="1"/>
            <p:nvPr/>
          </p:nvSpPr>
          <p:spPr>
            <a:xfrm>
              <a:off x="510787" y="393412"/>
              <a:ext cx="81416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>
                <a:tabLst>
                  <a:tab pos="6005513" algn="l"/>
                  <a:tab pos="7359650" algn="l"/>
                </a:tabLst>
              </a:pPr>
              <a:r>
                <a:rPr lang="en-AU" sz="1200" b="1" dirty="0" smtClean="0">
                  <a:latin typeface="Arial Narrow" panose="020B0606020202030204" pitchFamily="34" charset="0"/>
                  <a:cs typeface="Arial" panose="020B0604020202020204" pitchFamily="34" charset="0"/>
                </a:rPr>
                <a:t>Study ID	ES (95%CI)	% Weight</a:t>
              </a:r>
              <a:endParaRPr lang="en-AU" sz="1200" b="1" dirty="0">
                <a:latin typeface="Arial Narrow" panose="020B060602020203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Straight Connector 7"/>
            <p:cNvCxnSpPr/>
            <p:nvPr/>
          </p:nvCxnSpPr>
          <p:spPr>
            <a:xfrm>
              <a:off x="597415" y="666647"/>
              <a:ext cx="8141677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3658" t="17107" r="2331" b="5934"/>
          <a:stretch/>
        </p:blipFill>
        <p:spPr>
          <a:xfrm>
            <a:off x="433789" y="676272"/>
            <a:ext cx="8257177" cy="602291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396311" y="6431808"/>
            <a:ext cx="8141677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tabLst>
                <a:tab pos="4129088" algn="l"/>
                <a:tab pos="7359650" algn="l"/>
              </a:tabLst>
            </a:pPr>
            <a:r>
              <a:rPr lang="en-AU" sz="1200" b="1" dirty="0" smtClean="0">
                <a:latin typeface="Arial Narrow" panose="020B0606020202030204" pitchFamily="34" charset="0"/>
                <a:cs typeface="Arial" panose="020B0604020202020204" pitchFamily="34" charset="0"/>
              </a:rPr>
              <a:t>	Urine volume (mL/24-hour)	</a:t>
            </a:r>
            <a:endParaRPr lang="en-AU" sz="1200" b="1" dirty="0"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28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2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imes New Roman</vt:lpstr>
      <vt:lpstr>Office Theme</vt:lpstr>
      <vt:lpstr>PowerPoint Presentation</vt:lpstr>
    </vt:vector>
  </TitlesOfParts>
  <Company>Deaki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sey Beckford</dc:creator>
  <cp:lastModifiedBy>Kelsey Beckford</cp:lastModifiedBy>
  <cp:revision>10</cp:revision>
  <dcterms:created xsi:type="dcterms:W3CDTF">2018-10-21T04:42:34Z</dcterms:created>
  <dcterms:modified xsi:type="dcterms:W3CDTF">2019-10-16T05:17:38Z</dcterms:modified>
</cp:coreProperties>
</file>